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>
        <p:scale>
          <a:sx n="93" d="100"/>
          <a:sy n="93" d="100"/>
        </p:scale>
        <p:origin x="1332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7786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8309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7081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88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2632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428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3108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702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1735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0092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1870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D0879-61A0-411B-AD9A-FDAC0DFFEF0A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FAA15-C293-450B-A85E-A796ED8BEED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097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tângulo 6"/>
          <p:cNvSpPr/>
          <p:nvPr/>
        </p:nvSpPr>
        <p:spPr>
          <a:xfrm>
            <a:off x="82937" y="3761764"/>
            <a:ext cx="6717374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tabLst>
                <a:tab pos="3002893" algn="l"/>
              </a:tabLst>
            </a:pPr>
            <a:r>
              <a:rPr lang="en-US" sz="1200" b="1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nitored inside the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pen top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mbers (OTCs) used for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mbient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elevated [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</a:t>
            </a:r>
            <a:r>
              <a:rPr lang="en-US" sz="1200" baseline="-25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21 </a:t>
            </a:r>
            <a:r>
              <a:rPr lang="en-US" sz="1200" kern="0" dirty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ys 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exposure. </a:t>
            </a:r>
            <a:r>
              <a:rPr lang="en-US" sz="12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ch point represents </a:t>
            </a:r>
            <a:r>
              <a:rPr lang="en-US" sz="1200" dirty="0" smtClean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daily average</a:t>
            </a:r>
            <a:r>
              <a:rPr lang="en-US" sz="1200" kern="0" dirty="0" smtClean="0">
                <a:solidFill>
                  <a:srgbClr val="11111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tabLst>
                <a:tab pos="3002893" algn="l"/>
              </a:tabLst>
            </a:pP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7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/>
          </a:p>
        </p:txBody>
      </p:sp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793713"/>
              </p:ext>
            </p:extLst>
          </p:nvPr>
        </p:nvGraphicFramePr>
        <p:xfrm>
          <a:off x="82937" y="926370"/>
          <a:ext cx="6717374" cy="264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SPW 10.0 Graph" r:id="rId3" imgW="11386080" imgH="4484880" progId="SigmaPlotGraphicObject.9">
                  <p:embed/>
                </p:oleObj>
              </mc:Choice>
              <mc:Fallback>
                <p:oleObj name="SPW 10.0 Graph" r:id="rId3" imgW="11386080" imgH="448488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937" y="926370"/>
                        <a:ext cx="6717374" cy="264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74796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8</TotalTime>
  <Words>42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SPW 10.0 Graph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29</cp:revision>
  <dcterms:created xsi:type="dcterms:W3CDTF">2019-04-29T12:03:19Z</dcterms:created>
  <dcterms:modified xsi:type="dcterms:W3CDTF">2020-05-01T01:17:17Z</dcterms:modified>
</cp:coreProperties>
</file>